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inimized">
    <p:restoredLeft sz="0" autoAdjust="0"/>
    <p:restoredTop sz="0" autoAdjust="0"/>
  </p:normalViewPr>
  <p:slideViewPr>
    <p:cSldViewPr snapToGrid="0">
      <p:cViewPr varScale="1">
        <p:scale>
          <a:sx n="17" d="100"/>
          <a:sy n="17" d="100"/>
        </p:scale>
        <p:origin x="2920" y="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31B358-E3AC-F05D-4100-F21F9F978ED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4F80271-A9AA-73CD-BEEB-D4078A53EC8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20F045-51BD-E449-911C-83FAA6B1F7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8C91A-3403-42C6-B8E0-D9AAAAD350FA}" type="datetimeFigureOut">
              <a:rPr lang="en-IN" smtClean="0"/>
              <a:t>21-0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64530A-2131-BCA5-2A7C-4E4B628852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A93470-AA74-F5B7-BAC8-F54975A5A3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7344D-57CD-493A-A765-1576A1AC051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690349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198D74-F58C-59C8-5B0D-EC8A8E8139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B0F903B-AEF6-FD4A-214E-A633FF1C48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0F39B9-3AC0-BF83-5042-E00F3AB9DB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8C91A-3403-42C6-B8E0-D9AAAAD350FA}" type="datetimeFigureOut">
              <a:rPr lang="en-IN" smtClean="0"/>
              <a:t>21-0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522170-77B1-F252-D032-E54AC2A9D2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34D1D2-035B-CF83-B5A8-B94EE87E0C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7344D-57CD-493A-A765-1576A1AC051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323995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761E582-6EC4-8EC3-3850-6072F9E571B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D7DD5B3-46BD-6F3D-7EE1-D4655BF0A22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1BF157-4337-3811-1489-21D21A216F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8C91A-3403-42C6-B8E0-D9AAAAD350FA}" type="datetimeFigureOut">
              <a:rPr lang="en-IN" smtClean="0"/>
              <a:t>21-0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D9334D-9948-A912-BEC5-F7F94CCFC0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2539EA-A970-206C-791F-A0623BD9F5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7344D-57CD-493A-A765-1576A1AC051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238008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1FB931-EB51-83A8-777A-C058C937A8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758E5A-A4CE-4A89-9E1F-B5E295CD6C9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6FDBEB-2978-D8E1-4591-AC8659389B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8C91A-3403-42C6-B8E0-D9AAAAD350FA}" type="datetimeFigureOut">
              <a:rPr lang="en-IN" smtClean="0"/>
              <a:t>21-0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E4332A-358D-B709-FD72-E41A655879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FB21D8-4EAB-E004-8158-9C94AF8154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7344D-57CD-493A-A765-1576A1AC051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931869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2B54A1-8D7E-57F0-8FE0-AF05BB7ED0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34506DB-CC9F-A97F-E686-BF682BF9E0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C33877-98C5-4A1F-BFD9-FA28F5A106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8C91A-3403-42C6-B8E0-D9AAAAD350FA}" type="datetimeFigureOut">
              <a:rPr lang="en-IN" smtClean="0"/>
              <a:t>21-0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B234C9-EF26-50A5-99F7-9641EDC626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26DB0A-60F2-51D5-ED17-E23F7D7370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7344D-57CD-493A-A765-1576A1AC051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146973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D7C3EA-0803-65E3-9A30-DBE14FEC9F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3D09F7-B3B3-F054-CBF3-D5F0C8BC6C4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51A931D-8407-1CF6-082E-9EAB059E58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568220F-CC46-8639-1093-CD12F97EE4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8C91A-3403-42C6-B8E0-D9AAAAD350FA}" type="datetimeFigureOut">
              <a:rPr lang="en-IN" smtClean="0"/>
              <a:t>21-02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E3341F-F46B-4161-69D2-7A81C091A7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677A2E-EFB8-FD1A-792F-1D858C9BDE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7344D-57CD-493A-A765-1576A1AC051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570120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2E396F-B551-4ECB-BE28-6F3525FDEC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1D0368-9AB9-DAE4-BDDB-B51EB558A2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5EC8298-794E-BF46-233B-C1C4404B6E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A5E3843-7686-0EBF-DC5A-24DEFFEE7EE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A160154-50F5-B328-6544-D0CA4042993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1960F86-6A71-D145-0E37-38D4ADE84A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8C91A-3403-42C6-B8E0-D9AAAAD350FA}" type="datetimeFigureOut">
              <a:rPr lang="en-IN" smtClean="0"/>
              <a:t>21-02-2024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95740C2-59C4-8EF9-F899-862FEEE28D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F1A016A-7B12-ABC2-1B29-3FE1643DA7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7344D-57CD-493A-A765-1576A1AC051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327361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607775-18A1-9D7E-BE9E-C1CACCCFEA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524C344-E6A2-6DE0-34CB-C6DC3BD95F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8C91A-3403-42C6-B8E0-D9AAAAD350FA}" type="datetimeFigureOut">
              <a:rPr lang="en-IN" smtClean="0"/>
              <a:t>21-02-2024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CFC6652-58DA-1C37-08B2-5BCCB0167D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DAC1829-55D2-0393-897A-CADBB9261D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7344D-57CD-493A-A765-1576A1AC051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688699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F0A2E22-C5B2-49BB-5FD9-1179403BEB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8C91A-3403-42C6-B8E0-D9AAAAD350FA}" type="datetimeFigureOut">
              <a:rPr lang="en-IN" smtClean="0"/>
              <a:t>21-02-2024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B028449-9256-FF5D-93C1-4065913CF5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8FCF230-699F-8BE1-CD47-BE7BDBD8C9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7344D-57CD-493A-A765-1576A1AC051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430814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84E1D7-ECF6-33C9-4E06-CCA26E41D7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5812D4-5036-FF9F-7E26-6E2D3B772C5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D8A34BC-2643-7EB8-59A5-09A8923AAA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93452C-1EAE-0071-48C0-B37A12B7A5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8C91A-3403-42C6-B8E0-D9AAAAD350FA}" type="datetimeFigureOut">
              <a:rPr lang="en-IN" smtClean="0"/>
              <a:t>21-02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0D68AB-93DD-ED63-FF7C-9219B4A9BE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59A0CEE-6853-A716-7988-CACDCA3363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7344D-57CD-493A-A765-1576A1AC051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0609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623541-F4B1-A215-5A56-6A57D11FC3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1282F98-0FB6-DADA-6EDA-E8D798FC1D9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3D23DF5-5B3B-D758-9626-37D1E18442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DB0A32-F2B2-2C9D-D5DE-85E41E2D5D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8C91A-3403-42C6-B8E0-D9AAAAD350FA}" type="datetimeFigureOut">
              <a:rPr lang="en-IN" smtClean="0"/>
              <a:t>21-02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F77B980-2446-5797-6569-87F955D439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EE03EC-A5C3-E35E-48B1-D098C353DE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97344D-57CD-493A-A765-1576A1AC051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685446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96089A5-3EB7-7127-D89E-CBF2C4C167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A6263BB-9C4A-89DD-6648-AA5353045A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A4A07F-D492-80D9-93B6-F88A86D1DDD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78C91A-3403-42C6-B8E0-D9AAAAD350FA}" type="datetimeFigureOut">
              <a:rPr lang="en-IN" smtClean="0"/>
              <a:t>21-0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ABFEB0-65CF-D572-A454-3E751D9E52A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00E671-B9C5-5964-A66E-042AA0BF1E6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97344D-57CD-493A-A765-1576A1AC051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857802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01210ED-640A-FD58-99F7-B4675C87555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33" t="13585" r="31802" b="11447"/>
          <a:stretch/>
        </p:blipFill>
        <p:spPr>
          <a:xfrm>
            <a:off x="2173857" y="931653"/>
            <a:ext cx="5046452" cy="5141344"/>
          </a:xfrm>
          <a:prstGeom prst="rect">
            <a:avLst/>
          </a:prstGeom>
        </p:spPr>
      </p:pic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F1E10E27-3C89-1EAC-4EC7-729E2473E2F8}"/>
              </a:ext>
            </a:extLst>
          </p:cNvPr>
          <p:cNvCxnSpPr>
            <a:cxnSpLocks/>
          </p:cNvCxnSpPr>
          <p:nvPr/>
        </p:nvCxnSpPr>
        <p:spPr>
          <a:xfrm>
            <a:off x="4261452" y="1854679"/>
            <a:ext cx="0" cy="267419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43D7A691-39E5-23BA-8A0B-23D6569A0784}"/>
              </a:ext>
            </a:extLst>
          </p:cNvPr>
          <p:cNvSpPr txBox="1"/>
          <p:nvPr/>
        </p:nvSpPr>
        <p:spPr>
          <a:xfrm>
            <a:off x="327804" y="5974117"/>
            <a:ext cx="1148175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he red arrow shows the location of the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klo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laria Research Unit (SMRU) in Tak province, Thailand where the sample collection was performed.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786634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29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lit Mohan</dc:creator>
  <cp:lastModifiedBy>Juan Pablo Bifani (Prof)</cp:lastModifiedBy>
  <cp:revision>5</cp:revision>
  <dcterms:created xsi:type="dcterms:W3CDTF">2024-02-08T04:52:57Z</dcterms:created>
  <dcterms:modified xsi:type="dcterms:W3CDTF">2024-02-21T07:24:34Z</dcterms:modified>
</cp:coreProperties>
</file>